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4" d="100"/>
          <a:sy n="124" d="100"/>
        </p:scale>
        <p:origin x="1224" y="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F98F2-4E01-4F53-9673-5DFCB0C18843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B5DCD-BAA3-4447-8DF2-FE417118976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95071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F98F2-4E01-4F53-9673-5DFCB0C18843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B5DCD-BAA3-4447-8DF2-FE417118976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8332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F98F2-4E01-4F53-9673-5DFCB0C18843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B5DCD-BAA3-4447-8DF2-FE417118976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8781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F98F2-4E01-4F53-9673-5DFCB0C18843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B5DCD-BAA3-4447-8DF2-FE417118976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23649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F98F2-4E01-4F53-9673-5DFCB0C18843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B5DCD-BAA3-4447-8DF2-FE417118976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11185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F98F2-4E01-4F53-9673-5DFCB0C18843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B5DCD-BAA3-4447-8DF2-FE417118976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4074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F98F2-4E01-4F53-9673-5DFCB0C18843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B5DCD-BAA3-4447-8DF2-FE417118976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2020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F98F2-4E01-4F53-9673-5DFCB0C18843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B5DCD-BAA3-4447-8DF2-FE417118976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42692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F98F2-4E01-4F53-9673-5DFCB0C18843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B5DCD-BAA3-4447-8DF2-FE417118976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77927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F98F2-4E01-4F53-9673-5DFCB0C18843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B5DCD-BAA3-4447-8DF2-FE417118976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7211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F98F2-4E01-4F53-9673-5DFCB0C18843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B5DCD-BAA3-4447-8DF2-FE417118976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6723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9F98F2-4E01-4F53-9673-5DFCB0C18843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8B5DCD-BAA3-4447-8DF2-FE417118976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92764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52400" y="5892800"/>
            <a:ext cx="8534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/>
              <a:t>Fig. S1: Frequency distribution of TG (a), NG (b), T50 (c) and AUC (d) under control (green) and after controlled deterioration tests (brown) in </a:t>
            </a:r>
            <a:r>
              <a:rPr lang="en-US" sz="1200"/>
              <a:t>the Beinhart-1000 </a:t>
            </a:r>
            <a:r>
              <a:rPr lang="en-US" sz="1200" dirty="0"/>
              <a:t>x Hicks mapping population. Thick dashed lines indicate means of respective traits.  </a:t>
            </a:r>
          </a:p>
        </p:txBody>
      </p:sp>
      <p:grpSp>
        <p:nvGrpSpPr>
          <p:cNvPr id="4" name="Group 3"/>
          <p:cNvGrpSpPr/>
          <p:nvPr/>
        </p:nvGrpSpPr>
        <p:grpSpPr>
          <a:xfrm>
            <a:off x="547850" y="304800"/>
            <a:ext cx="7605550" cy="5588000"/>
            <a:chOff x="547850" y="304800"/>
            <a:chExt cx="7605550" cy="5588000"/>
          </a:xfrm>
        </p:grpSpPr>
        <p:pic>
          <p:nvPicPr>
            <p:cNvPr id="1026" name="Picture 2" descr="C:\Users\Dr. A. Rehman\Documents\TG.tiff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14400" y="381000"/>
              <a:ext cx="3610369" cy="2743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7" name="Picture 3" descr="C:\Users\Dr. A. Rehman\Documents\NG.tiff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43031" y="373743"/>
              <a:ext cx="3610369" cy="2743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8" name="Picture 4" descr="C:\Users\Dr. A. Rehman\Documents\T50.tiff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10304" y="3149600"/>
              <a:ext cx="3610369" cy="2743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9" name="Picture 5" descr="C:\Users\Dr. A. Rehman\Documents\AUC.tiff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43031" y="3149600"/>
              <a:ext cx="3610369" cy="2743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" name="TextBox 1"/>
            <p:cNvSpPr txBox="1"/>
            <p:nvPr/>
          </p:nvSpPr>
          <p:spPr>
            <a:xfrm>
              <a:off x="547850" y="304800"/>
              <a:ext cx="4427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(a)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281650" y="348424"/>
              <a:ext cx="4523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(b)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50310" y="3059668"/>
              <a:ext cx="4251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(c)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271286" y="3106372"/>
              <a:ext cx="4523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(d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321277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6</Words>
  <Application>Microsoft Office PowerPoint</Application>
  <PresentationFormat>Bildschirmpräsentation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. A. Rehman</dc:creator>
  <cp:lastModifiedBy>Andreas Boerner</cp:lastModifiedBy>
  <cp:revision>12</cp:revision>
  <cp:lastPrinted>2021-02-03T06:24:29Z</cp:lastPrinted>
  <dcterms:created xsi:type="dcterms:W3CDTF">2021-02-02T08:30:38Z</dcterms:created>
  <dcterms:modified xsi:type="dcterms:W3CDTF">2021-02-05T06:32:04Z</dcterms:modified>
</cp:coreProperties>
</file>